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6" r:id="rId2"/>
    <p:sldId id="265" r:id="rId3"/>
    <p:sldId id="263" r:id="rId4"/>
  </p:sldIdLst>
  <p:sldSz cx="7559675" cy="1069181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류 성원" initials="류성" lastIdx="7" clrIdx="0">
    <p:extLst/>
  </p:cmAuthor>
  <p:cmAuthor id="2" name="이 다겸" initials="이다" lastIdx="9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698ECA-8393-E545-B736-D2FC94E2C111}" v="91" dt="2021-08-16T23:13:01.90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00"/>
  </p:normalViewPr>
  <p:slideViewPr>
    <p:cSldViewPr snapToGrid="0">
      <p:cViewPr varScale="1">
        <p:scale>
          <a:sx n="55" d="100"/>
          <a:sy n="55" d="100"/>
        </p:scale>
        <p:origin x="-2676" y="-90"/>
      </p:cViewPr>
      <p:guideLst>
        <p:guide orient="horz" pos="3367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5" Type="http://schemas.microsoft.com/office/2016/11/relationships/changesInfo" Target="changesInfos/changesInfo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이 다겸" userId="4f7caebc228b2675" providerId="Windows Live" clId="Web-{5556801D-770D-4BCB-8C37-A1C84A99E3DB}"/>
    <pc:docChg chg="modSld">
      <pc:chgData name="이 다겸" userId="4f7caebc228b2675" providerId="Windows Live" clId="Web-{5556801D-770D-4BCB-8C37-A1C84A99E3DB}" dt="2021-08-12T23:34:46.986" v="12" actId="20577"/>
      <pc:docMkLst>
        <pc:docMk/>
      </pc:docMkLst>
      <pc:sldChg chg="modSp">
        <pc:chgData name="이 다겸" userId="4f7caebc228b2675" providerId="Windows Live" clId="Web-{5556801D-770D-4BCB-8C37-A1C84A99E3DB}" dt="2021-08-12T23:34:46.986" v="12" actId="20577"/>
        <pc:sldMkLst>
          <pc:docMk/>
          <pc:sldMk cId="4061709889" sldId="268"/>
        </pc:sldMkLst>
        <pc:spChg chg="mod">
          <ac:chgData name="이 다겸" userId="4f7caebc228b2675" providerId="Windows Live" clId="Web-{5556801D-770D-4BCB-8C37-A1C84A99E3DB}" dt="2021-08-12T23:34:46.986" v="12" actId="20577"/>
          <ac:spMkLst>
            <pc:docMk/>
            <pc:sldMk cId="4061709889" sldId="268"/>
            <ac:spMk id="4" creationId="{00000000-0000-0000-0000-000000000000}"/>
          </ac:spMkLst>
        </pc:spChg>
      </pc:sldChg>
    </pc:docChg>
  </pc:docChgLst>
  <pc:docChgLst>
    <pc:chgData name="류 성원" userId="694a68cde353d9c1" providerId="LiveId" clId="{95698ECA-8393-E545-B736-D2FC94E2C111}"/>
    <pc:docChg chg="custSel addSld delSld modSld">
      <pc:chgData name="류 성원" userId="694a68cde353d9c1" providerId="LiveId" clId="{95698ECA-8393-E545-B736-D2FC94E2C111}" dt="2021-08-16T23:13:57.105" v="249" actId="6549"/>
      <pc:docMkLst>
        <pc:docMk/>
      </pc:docMkLst>
      <pc:sldChg chg="modSp add del mod addCm modCm">
        <pc:chgData name="류 성원" userId="694a68cde353d9c1" providerId="LiveId" clId="{95698ECA-8393-E545-B736-D2FC94E2C111}" dt="2021-08-05T02:36:42.581" v="13"/>
        <pc:sldMkLst>
          <pc:docMk/>
          <pc:sldMk cId="2570747703" sldId="257"/>
        </pc:sldMkLst>
        <pc:spChg chg="mod">
          <ac:chgData name="류 성원" userId="694a68cde353d9c1" providerId="LiveId" clId="{95698ECA-8393-E545-B736-D2FC94E2C111}" dt="2021-08-05T02:33:45.742" v="9" actId="114"/>
          <ac:spMkLst>
            <pc:docMk/>
            <pc:sldMk cId="2570747703" sldId="257"/>
            <ac:spMk id="4" creationId="{00000000-0000-0000-0000-000000000000}"/>
          </ac:spMkLst>
        </pc:spChg>
      </pc:sldChg>
      <pc:sldChg chg="add del">
        <pc:chgData name="류 성원" userId="694a68cde353d9c1" providerId="LiveId" clId="{95698ECA-8393-E545-B736-D2FC94E2C111}" dt="2021-08-05T02:33:05.092" v="6"/>
        <pc:sldMkLst>
          <pc:docMk/>
          <pc:sldMk cId="36123283" sldId="258"/>
        </pc:sldMkLst>
      </pc:sldChg>
      <pc:sldChg chg="modSp add del mod addCm modCm">
        <pc:chgData name="류 성원" userId="694a68cde353d9c1" providerId="LiveId" clId="{95698ECA-8393-E545-B736-D2FC94E2C111}" dt="2021-08-12T23:55:03.703" v="152" actId="114"/>
        <pc:sldMkLst>
          <pc:docMk/>
          <pc:sldMk cId="1262032952" sldId="259"/>
        </pc:sldMkLst>
        <pc:spChg chg="mod">
          <ac:chgData name="류 성원" userId="694a68cde353d9c1" providerId="LiveId" clId="{95698ECA-8393-E545-B736-D2FC94E2C111}" dt="2021-08-12T23:55:03.703" v="152" actId="114"/>
          <ac:spMkLst>
            <pc:docMk/>
            <pc:sldMk cId="1262032952" sldId="259"/>
            <ac:spMk id="4" creationId="{00000000-0000-0000-0000-000000000000}"/>
          </ac:spMkLst>
        </pc:spChg>
      </pc:sldChg>
      <pc:sldChg chg="modSp add del mod addCm delCm modCm">
        <pc:chgData name="류 성원" userId="694a68cde353d9c1" providerId="LiveId" clId="{95698ECA-8393-E545-B736-D2FC94E2C111}" dt="2021-08-16T23:04:38.462" v="228" actId="1592"/>
        <pc:sldMkLst>
          <pc:docMk/>
          <pc:sldMk cId="1200990163" sldId="261"/>
        </pc:sldMkLst>
        <pc:spChg chg="mod">
          <ac:chgData name="류 성원" userId="694a68cde353d9c1" providerId="LiveId" clId="{95698ECA-8393-E545-B736-D2FC94E2C111}" dt="2021-08-13T00:08:21.927" v="193" actId="6549"/>
          <ac:spMkLst>
            <pc:docMk/>
            <pc:sldMk cId="1200990163" sldId="261"/>
            <ac:spMk id="2" creationId="{00000000-0000-0000-0000-000000000000}"/>
          </ac:spMkLst>
        </pc:spChg>
      </pc:sldChg>
      <pc:sldChg chg="modSp add del mod">
        <pc:chgData name="류 성원" userId="694a68cde353d9c1" providerId="LiveId" clId="{95698ECA-8393-E545-B736-D2FC94E2C111}" dt="2021-08-16T23:13:57.105" v="249" actId="6549"/>
        <pc:sldMkLst>
          <pc:docMk/>
          <pc:sldMk cId="998814494" sldId="263"/>
        </pc:sldMkLst>
        <pc:spChg chg="mod">
          <ac:chgData name="류 성원" userId="694a68cde353d9c1" providerId="LiveId" clId="{95698ECA-8393-E545-B736-D2FC94E2C111}" dt="2021-08-16T23:13:57.105" v="249" actId="6549"/>
          <ac:spMkLst>
            <pc:docMk/>
            <pc:sldMk cId="998814494" sldId="263"/>
            <ac:spMk id="8" creationId="{00000000-0000-0000-0000-000000000000}"/>
          </ac:spMkLst>
        </pc:spChg>
      </pc:sldChg>
      <pc:sldChg chg="modSp add del mod addCm modCm">
        <pc:chgData name="류 성원" userId="694a68cde353d9c1" providerId="LiveId" clId="{95698ECA-8393-E545-B736-D2FC94E2C111}" dt="2021-08-16T23:07:56.053" v="237" actId="6549"/>
        <pc:sldMkLst>
          <pc:docMk/>
          <pc:sldMk cId="1726411316" sldId="265"/>
        </pc:sldMkLst>
        <pc:spChg chg="mod">
          <ac:chgData name="류 성원" userId="694a68cde353d9c1" providerId="LiveId" clId="{95698ECA-8393-E545-B736-D2FC94E2C111}" dt="2021-08-16T23:07:56.053" v="237" actId="6549"/>
          <ac:spMkLst>
            <pc:docMk/>
            <pc:sldMk cId="1726411316" sldId="265"/>
            <ac:spMk id="2" creationId="{00000000-0000-0000-0000-000000000000}"/>
          </ac:spMkLst>
        </pc:spChg>
      </pc:sldChg>
      <pc:sldChg chg="modSp add del mod addCm modCm">
        <pc:chgData name="류 성원" userId="694a68cde353d9c1" providerId="LiveId" clId="{95698ECA-8393-E545-B736-D2FC94E2C111}" dt="2021-08-16T23:13:01.900" v="245"/>
        <pc:sldMkLst>
          <pc:docMk/>
          <pc:sldMk cId="3046632486" sldId="266"/>
        </pc:sldMkLst>
        <pc:spChg chg="mod">
          <ac:chgData name="류 성원" userId="694a68cde353d9c1" providerId="LiveId" clId="{95698ECA-8393-E545-B736-D2FC94E2C111}" dt="2021-08-16T23:13:01.900" v="245"/>
          <ac:spMkLst>
            <pc:docMk/>
            <pc:sldMk cId="3046632486" sldId="266"/>
            <ac:spMk id="29" creationId="{00000000-0000-0000-0000-000000000000}"/>
          </ac:spMkLst>
        </pc:spChg>
      </pc:sldChg>
      <pc:sldChg chg="add del addCm modCm">
        <pc:chgData name="류 성원" userId="694a68cde353d9c1" providerId="LiveId" clId="{95698ECA-8393-E545-B736-D2FC94E2C111}" dt="2021-08-05T02:37:00.765" v="15"/>
        <pc:sldMkLst>
          <pc:docMk/>
          <pc:sldMk cId="3983201304" sldId="267"/>
        </pc:sldMkLst>
      </pc:sldChg>
      <pc:sldChg chg="new del">
        <pc:chgData name="류 성원" userId="694a68cde353d9c1" providerId="LiveId" clId="{95698ECA-8393-E545-B736-D2FC94E2C111}" dt="2021-08-05T01:51:32.651" v="2" actId="2696"/>
        <pc:sldMkLst>
          <pc:docMk/>
          <pc:sldMk cId="2835011354" sldId="268"/>
        </pc:sldMkLst>
      </pc:sldChg>
      <pc:sldChg chg="modSp mod">
        <pc:chgData name="류 성원" userId="694a68cde353d9c1" providerId="LiveId" clId="{95698ECA-8393-E545-B736-D2FC94E2C111}" dt="2021-08-12T23:45:10.814" v="151" actId="20577"/>
        <pc:sldMkLst>
          <pc:docMk/>
          <pc:sldMk cId="4061709889" sldId="268"/>
        </pc:sldMkLst>
        <pc:spChg chg="mod">
          <ac:chgData name="류 성원" userId="694a68cde353d9c1" providerId="LiveId" clId="{95698ECA-8393-E545-B736-D2FC94E2C111}" dt="2021-08-12T23:45:10.814" v="151" actId="20577"/>
          <ac:spMkLst>
            <pc:docMk/>
            <pc:sldMk cId="4061709889" sldId="268"/>
            <ac:spMk id="4" creationId="{00000000-0000-0000-0000-000000000000}"/>
          </ac:spMkLst>
        </pc:spChg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573778606" sldId="269"/>
        </pc:sldMkLst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135064772" sldId="270"/>
        </pc:sldMkLst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226462088" sldId="271"/>
        </pc:sldMkLst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3503636" sldId="272"/>
        </pc:sldMkLst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052572516" sldId="273"/>
        </pc:sldMkLst>
      </pc:sldChg>
      <pc:sldChg chg="modSp add del mod">
        <pc:chgData name="류 성원" userId="694a68cde353d9c1" providerId="LiveId" clId="{95698ECA-8393-E545-B736-D2FC94E2C111}" dt="2021-08-05T02:33:12.640" v="7" actId="2696"/>
        <pc:sldMkLst>
          <pc:docMk/>
          <pc:sldMk cId="1246410250" sldId="274"/>
        </pc:sldMkLst>
        <pc:spChg chg="mod">
          <ac:chgData name="류 성원" userId="694a68cde353d9c1" providerId="LiveId" clId="{95698ECA-8393-E545-B736-D2FC94E2C111}" dt="2021-08-05T01:56:24.420" v="3" actId="58"/>
          <ac:spMkLst>
            <pc:docMk/>
            <pc:sldMk cId="1246410250" sldId="274"/>
            <ac:spMk id="2" creationId="{00000000-0000-0000-0000-000000000000}"/>
          </ac:spMkLst>
        </pc:spChg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1488463508" sldId="275"/>
        </pc:sldMkLst>
      </pc:sldChg>
      <pc:sldChg chg="add del">
        <pc:chgData name="류 성원" userId="694a68cde353d9c1" providerId="LiveId" clId="{95698ECA-8393-E545-B736-D2FC94E2C111}" dt="2021-08-05T02:33:12.640" v="7" actId="2696"/>
        <pc:sldMkLst>
          <pc:docMk/>
          <pc:sldMk cId="2633610903" sldId="276"/>
        </pc:sldMkLst>
      </pc:sldChg>
      <pc:sldChg chg="new del">
        <pc:chgData name="류 성원" userId="694a68cde353d9c1" providerId="LiveId" clId="{95698ECA-8393-E545-B736-D2FC94E2C111}" dt="2021-08-05T02:33:12.640" v="7" actId="2696"/>
        <pc:sldMkLst>
          <pc:docMk/>
          <pc:sldMk cId="1641616954" sldId="277"/>
        </pc:sldMkLst>
      </pc:sldChg>
      <pc:sldChg chg="new del">
        <pc:chgData name="류 성원" userId="694a68cde353d9c1" providerId="LiveId" clId="{95698ECA-8393-E545-B736-D2FC94E2C111}" dt="2021-08-05T02:33:15.439" v="8" actId="2696"/>
        <pc:sldMkLst>
          <pc:docMk/>
          <pc:sldMk cId="317846009" sldId="278"/>
        </pc:sldMkLst>
      </pc:sldChg>
    </pc:docChg>
  </pc:docChgLst>
  <pc:docChgLst>
    <pc:chgData name="이 다겸" userId="4f7caebc228b2675" providerId="Windows Live" clId="Web-{C1C15027-7308-4265-AF18-DCEB770F7748}"/>
    <pc:docChg chg="modSld">
      <pc:chgData name="이 다겸" userId="4f7caebc228b2675" providerId="Windows Live" clId="Web-{C1C15027-7308-4265-AF18-DCEB770F7748}" dt="2021-08-05T12:00:35.657" v="49"/>
      <pc:docMkLst>
        <pc:docMk/>
      </pc:docMkLst>
      <pc:sldChg chg="modSp addCm">
        <pc:chgData name="이 다겸" userId="4f7caebc228b2675" providerId="Windows Live" clId="Web-{C1C15027-7308-4265-AF18-DCEB770F7748}" dt="2021-08-05T12:00:35.657" v="49"/>
        <pc:sldMkLst>
          <pc:docMk/>
          <pc:sldMk cId="2570747703" sldId="257"/>
        </pc:sldMkLst>
        <pc:spChg chg="mod">
          <ac:chgData name="이 다겸" userId="4f7caebc228b2675" providerId="Windows Live" clId="Web-{C1C15027-7308-4265-AF18-DCEB770F7748}" dt="2021-08-05T11:58:37.624" v="48" actId="20577"/>
          <ac:spMkLst>
            <pc:docMk/>
            <pc:sldMk cId="2570747703" sldId="257"/>
            <ac:spMk id="4" creationId="{00000000-0000-0000-0000-000000000000}"/>
          </ac:spMkLst>
        </pc:spChg>
      </pc:sldChg>
      <pc:sldChg chg="modSp addCm">
        <pc:chgData name="이 다겸" userId="4f7caebc228b2675" providerId="Windows Live" clId="Web-{C1C15027-7308-4265-AF18-DCEB770F7748}" dt="2021-08-05T11:57:16.325" v="35"/>
        <pc:sldMkLst>
          <pc:docMk/>
          <pc:sldMk cId="1262032952" sldId="259"/>
        </pc:sldMkLst>
        <pc:spChg chg="mod">
          <ac:chgData name="이 다겸" userId="4f7caebc228b2675" providerId="Windows Live" clId="Web-{C1C15027-7308-4265-AF18-DCEB770F7748}" dt="2021-08-05T11:50:54.906" v="29" actId="1076"/>
          <ac:spMkLst>
            <pc:docMk/>
            <pc:sldMk cId="1262032952" sldId="259"/>
            <ac:spMk id="3" creationId="{00000000-0000-0000-0000-000000000000}"/>
          </ac:spMkLst>
        </pc:spChg>
        <pc:spChg chg="mod">
          <ac:chgData name="이 다겸" userId="4f7caebc228b2675" providerId="Windows Live" clId="Web-{C1C15027-7308-4265-AF18-DCEB770F7748}" dt="2021-08-05T11:51:15.455" v="32" actId="20577"/>
          <ac:spMkLst>
            <pc:docMk/>
            <pc:sldMk cId="1262032952" sldId="259"/>
            <ac:spMk id="4" creationId="{00000000-0000-0000-0000-000000000000}"/>
          </ac:spMkLst>
        </pc:spChg>
      </pc:sldChg>
      <pc:sldChg chg="modSp addCm modCm">
        <pc:chgData name="이 다겸" userId="4f7caebc228b2675" providerId="Windows Live" clId="Web-{C1C15027-7308-4265-AF18-DCEB770F7748}" dt="2021-08-05T11:55:02.115" v="34"/>
        <pc:sldMkLst>
          <pc:docMk/>
          <pc:sldMk cId="3983201304" sldId="267"/>
        </pc:sldMkLst>
        <pc:spChg chg="mod">
          <ac:chgData name="이 다겸" userId="4f7caebc228b2675" providerId="Windows Live" clId="Web-{C1C15027-7308-4265-AF18-DCEB770F7748}" dt="2021-08-05T11:49:15.701" v="18" actId="20577"/>
          <ac:spMkLst>
            <pc:docMk/>
            <pc:sldMk cId="3983201304" sldId="267"/>
            <ac:spMk id="2" creationId="{00000000-0000-0000-0000-000000000000}"/>
          </ac:spMkLst>
        </pc:spChg>
      </pc:sldChg>
    </pc:docChg>
  </pc:docChgLst>
  <pc:docChgLst>
    <pc:chgData name="이 다겸" userId="4f7caebc228b2675" providerId="Windows Live" clId="Web-{1E443802-A3F2-4E86-A396-41FEA5C24005}"/>
    <pc:docChg chg="modSld">
      <pc:chgData name="이 다겸" userId="4f7caebc228b2675" providerId="Windows Live" clId="Web-{1E443802-A3F2-4E86-A396-41FEA5C24005}" dt="2021-08-12T12:39:38.705" v="242" actId="20577"/>
      <pc:docMkLst>
        <pc:docMk/>
      </pc:docMkLst>
      <pc:sldChg chg="modSp">
        <pc:chgData name="이 다겸" userId="4f7caebc228b2675" providerId="Windows Live" clId="Web-{1E443802-A3F2-4E86-A396-41FEA5C24005}" dt="2021-08-12T12:14:24.171" v="117" actId="20577"/>
        <pc:sldMkLst>
          <pc:docMk/>
          <pc:sldMk cId="36123283" sldId="258"/>
        </pc:sldMkLst>
        <pc:spChg chg="mod">
          <ac:chgData name="이 다겸" userId="4f7caebc228b2675" providerId="Windows Live" clId="Web-{1E443802-A3F2-4E86-A396-41FEA5C24005}" dt="2021-08-12T12:14:24.171" v="117" actId="20577"/>
          <ac:spMkLst>
            <pc:docMk/>
            <pc:sldMk cId="36123283" sldId="258"/>
            <ac:spMk id="3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39:27.018" v="241"/>
        <pc:sldMkLst>
          <pc:docMk/>
          <pc:sldMk cId="1262032952" sldId="259"/>
        </pc:sldMkLst>
        <pc:spChg chg="mod">
          <ac:chgData name="이 다겸" userId="4f7caebc228b2675" providerId="Windows Live" clId="Web-{1E443802-A3F2-4E86-A396-41FEA5C24005}" dt="2021-08-12T12:39:27.018" v="241"/>
          <ac:spMkLst>
            <pc:docMk/>
            <pc:sldMk cId="1262032952" sldId="259"/>
            <ac:spMk id="4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39:20.799" v="240"/>
        <pc:sldMkLst>
          <pc:docMk/>
          <pc:sldMk cId="1200990163" sldId="261"/>
        </pc:sldMkLst>
        <pc:spChg chg="mod">
          <ac:chgData name="이 다겸" userId="4f7caebc228b2675" providerId="Windows Live" clId="Web-{1E443802-A3F2-4E86-A396-41FEA5C24005}" dt="2021-08-12T12:39:20.799" v="240"/>
          <ac:spMkLst>
            <pc:docMk/>
            <pc:sldMk cId="1200990163" sldId="261"/>
            <ac:spMk id="2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39:01.923" v="238"/>
        <pc:sldMkLst>
          <pc:docMk/>
          <pc:sldMk cId="998814494" sldId="263"/>
        </pc:sldMkLst>
        <pc:spChg chg="mod">
          <ac:chgData name="이 다겸" userId="4f7caebc228b2675" providerId="Windows Live" clId="Web-{1E443802-A3F2-4E86-A396-41FEA5C24005}" dt="2021-08-12T12:39:01.923" v="238"/>
          <ac:spMkLst>
            <pc:docMk/>
            <pc:sldMk cId="998814494" sldId="263"/>
            <ac:spMk id="8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26:53.593" v="226" actId="20577"/>
        <pc:sldMkLst>
          <pc:docMk/>
          <pc:sldMk cId="1726411316" sldId="265"/>
        </pc:sldMkLst>
        <pc:spChg chg="mod">
          <ac:chgData name="이 다겸" userId="4f7caebc228b2675" providerId="Windows Live" clId="Web-{1E443802-A3F2-4E86-A396-41FEA5C24005}" dt="2021-08-12T12:26:53.593" v="226" actId="20577"/>
          <ac:spMkLst>
            <pc:docMk/>
            <pc:sldMk cId="1726411316" sldId="265"/>
            <ac:spMk id="2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39:08.080" v="239"/>
        <pc:sldMkLst>
          <pc:docMk/>
          <pc:sldMk cId="3046632486" sldId="266"/>
        </pc:sldMkLst>
        <pc:spChg chg="mod">
          <ac:chgData name="이 다겸" userId="4f7caebc228b2675" providerId="Windows Live" clId="Web-{1E443802-A3F2-4E86-A396-41FEA5C24005}" dt="2021-08-12T12:39:08.080" v="239"/>
          <ac:spMkLst>
            <pc:docMk/>
            <pc:sldMk cId="3046632486" sldId="266"/>
            <ac:spMk id="29" creationId="{00000000-0000-0000-0000-000000000000}"/>
          </ac:spMkLst>
        </pc:spChg>
      </pc:sldChg>
      <pc:sldChg chg="modSp">
        <pc:chgData name="이 다겸" userId="4f7caebc228b2675" providerId="Windows Live" clId="Web-{1E443802-A3F2-4E86-A396-41FEA5C24005}" dt="2021-08-12T12:39:38.705" v="242" actId="20577"/>
        <pc:sldMkLst>
          <pc:docMk/>
          <pc:sldMk cId="4061709889" sldId="268"/>
        </pc:sldMkLst>
        <pc:spChg chg="mod">
          <ac:chgData name="이 다겸" userId="4f7caebc228b2675" providerId="Windows Live" clId="Web-{1E443802-A3F2-4E86-A396-41FEA5C24005}" dt="2021-08-12T12:39:38.705" v="242" actId="20577"/>
          <ac:spMkLst>
            <pc:docMk/>
            <pc:sldMk cId="4061709889" sldId="268"/>
            <ac:spMk id="4" creationId="{00000000-0000-0000-0000-000000000000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CCA67E-582A-4589-90E8-76ABD68B0B5C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41425"/>
            <a:ext cx="23653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5A4D4-2257-44A6-9F88-062E62FAC2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008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489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1532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176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5904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8722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1184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9910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4385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5347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1994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2928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777DA-704E-47F0-9557-E98585603994}" type="datetimeFigureOut">
              <a:rPr lang="ko-KR" altLang="en-US" smtClean="0"/>
              <a:t>2021-10-05(Tuesday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F2108-C980-4025-97C7-2F666C736C9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4006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1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1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직사각형 8"/>
          <p:cNvSpPr/>
          <p:nvPr/>
        </p:nvSpPr>
        <p:spPr>
          <a:xfrm>
            <a:off x="153794" y="5647687"/>
            <a:ext cx="7057538" cy="2062103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600" b="1" dirty="0" smtClean="0">
                <a:latin typeface="Palatino Linotype" panose="02040502050505030304" pitchFamily="18" charset="0"/>
                <a:ea typeface="+mn-lt"/>
                <a:cs typeface="Times New Roman"/>
              </a:rPr>
              <a:t>S1.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 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REMA for determining the 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activity of CC against Clarithromycin-resistant </a:t>
            </a:r>
            <a:r>
              <a:rPr lang="en-US" sz="1600" i="1" dirty="0">
                <a:latin typeface="Palatino Linotype" panose="02040502050505030304" pitchFamily="18" charset="0"/>
                <a:ea typeface="+mn-lt"/>
                <a:cs typeface="Times New Roman"/>
              </a:rPr>
              <a:t>M. </a:t>
            </a:r>
            <a:r>
              <a:rPr lang="en-US" sz="1600" i="1" dirty="0" err="1">
                <a:latin typeface="Palatino Linotype" panose="02040502050505030304" pitchFamily="18" charset="0"/>
                <a:ea typeface="+mn-lt"/>
                <a:cs typeface="Times New Roman"/>
              </a:rPr>
              <a:t>abscessus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 mutants. Clarithromycin-resistant </a:t>
            </a:r>
            <a:r>
              <a:rPr lang="en-US" sz="1600" i="1" dirty="0">
                <a:latin typeface="Palatino Linotype" panose="02040502050505030304" pitchFamily="18" charset="0"/>
                <a:ea typeface="+mn-lt"/>
                <a:cs typeface="Times New Roman"/>
              </a:rPr>
              <a:t>M. </a:t>
            </a:r>
            <a:r>
              <a:rPr lang="en-US" sz="1600" i="1" dirty="0" err="1">
                <a:latin typeface="Palatino Linotype" panose="02040502050505030304" pitchFamily="18" charset="0"/>
                <a:ea typeface="+mn-lt"/>
                <a:cs typeface="Times New Roman"/>
              </a:rPr>
              <a:t>abscessus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 mutants (</a:t>
            </a:r>
            <a:r>
              <a:rPr lang="en-US" sz="1600" i="1" dirty="0">
                <a:latin typeface="Palatino Linotype" panose="02040502050505030304" pitchFamily="18" charset="0"/>
                <a:ea typeface="+mn-lt"/>
                <a:cs typeface="Times New Roman"/>
              </a:rPr>
              <a:t>M. </a:t>
            </a:r>
            <a:r>
              <a:rPr lang="en-US" sz="1600" i="1" dirty="0" err="1">
                <a:latin typeface="Palatino Linotype" panose="02040502050505030304" pitchFamily="18" charset="0"/>
                <a:ea typeface="+mn-lt"/>
                <a:cs typeface="Times New Roman"/>
              </a:rPr>
              <a:t>abscessus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 CLR-R) were tested for their ability to grow in Mueller-Hinton medium when treated with 100 </a:t>
            </a:r>
            <a:r>
              <a:rPr lang="zh-CN" altLang="ko-KR" sz="1600" dirty="0">
                <a:latin typeface="Palatino Linotype" panose="02040502050505030304" pitchFamily="18" charset="0"/>
              </a:rPr>
              <a:t>㎍</a:t>
            </a:r>
            <a:r>
              <a:rPr lang="en-US" altLang="ko-KR" sz="1600" dirty="0">
                <a:latin typeface="Palatino Linotype" panose="02040502050505030304" pitchFamily="18" charset="0"/>
              </a:rPr>
              <a:t>/</a:t>
            </a:r>
            <a:r>
              <a:rPr lang="zh-CN" altLang="ko-KR" sz="1600" dirty="0">
                <a:latin typeface="Palatino Linotype" panose="02040502050505030304" pitchFamily="18" charset="0"/>
              </a:rPr>
              <a:t>㎖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 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to 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0.097</a:t>
            </a:r>
            <a:r>
              <a:rPr lang="zh-CN" altLang="ko-KR" sz="1600" dirty="0">
                <a:latin typeface="Palatino Linotype" panose="02040502050505030304" pitchFamily="18" charset="0"/>
              </a:rPr>
              <a:t> ㎍</a:t>
            </a:r>
            <a:r>
              <a:rPr lang="en-US" altLang="ko-KR" sz="1600" dirty="0">
                <a:latin typeface="Palatino Linotype" panose="02040502050505030304" pitchFamily="18" charset="0"/>
              </a:rPr>
              <a:t>/</a:t>
            </a:r>
            <a:r>
              <a:rPr lang="zh-CN" altLang="ko-KR" sz="1600" dirty="0">
                <a:latin typeface="Palatino Linotype" panose="02040502050505030304" pitchFamily="18" charset="0"/>
              </a:rPr>
              <a:t>㎖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 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of Clarithromycin (CLR) and CC. </a:t>
            </a:r>
            <a:r>
              <a:rPr lang="en-US" sz="1600" dirty="0" err="1" smtClean="0">
                <a:latin typeface="Palatino Linotype" panose="02040502050505030304" pitchFamily="18" charset="0"/>
                <a:ea typeface="+mn-lt"/>
                <a:cs typeface="Times New Roman"/>
              </a:rPr>
              <a:t>Resazurin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 added to each wells. Upon oxidation by live </a:t>
            </a:r>
            <a:r>
              <a:rPr lang="en-US" sz="1600" i="1" dirty="0" smtClean="0">
                <a:latin typeface="Palatino Linotype" panose="02040502050505030304" pitchFamily="18" charset="0"/>
                <a:ea typeface="+mn-lt"/>
                <a:cs typeface="Times New Roman"/>
              </a:rPr>
              <a:t>M. </a:t>
            </a:r>
            <a:r>
              <a:rPr lang="en-US" sz="1600" i="1" dirty="0" err="1" smtClean="0">
                <a:latin typeface="Palatino Linotype" panose="02040502050505030304" pitchFamily="18" charset="0"/>
                <a:ea typeface="+mn-lt"/>
                <a:cs typeface="Times New Roman"/>
              </a:rPr>
              <a:t>abscessus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, it turns pink, indicating growth of </a:t>
            </a:r>
            <a:r>
              <a:rPr lang="en-US" sz="1600" i="1" dirty="0" smtClean="0">
                <a:latin typeface="Palatino Linotype" panose="02040502050505030304" pitchFamily="18" charset="0"/>
                <a:ea typeface="+mn-lt"/>
                <a:cs typeface="Times New Roman"/>
              </a:rPr>
              <a:t>M. </a:t>
            </a:r>
            <a:r>
              <a:rPr lang="en-US" sz="1600" i="1" dirty="0" err="1" smtClean="0">
                <a:latin typeface="Palatino Linotype" panose="02040502050505030304" pitchFamily="18" charset="0"/>
                <a:ea typeface="+mn-lt"/>
                <a:cs typeface="Times New Roman"/>
              </a:rPr>
              <a:t>abscessus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. </a:t>
            </a:r>
            <a:r>
              <a:rPr lang="en-US" altLang="ko-KR" sz="1600" dirty="0">
                <a:latin typeface="Palatino Linotype" panose="02040502050505030304" pitchFamily="18" charset="0"/>
              </a:rPr>
              <a:t>Each experiment was performed in </a:t>
            </a:r>
            <a:r>
              <a:rPr lang="en-US" altLang="ko-KR" sz="1600" dirty="0" smtClean="0">
                <a:latin typeface="Palatino Linotype" panose="02040502050505030304" pitchFamily="18" charset="0"/>
              </a:rPr>
              <a:t>triplicate. </a:t>
            </a:r>
            <a:r>
              <a:rPr lang="en-US" altLang="ko-KR" sz="1600" dirty="0">
                <a:latin typeface="Palatino Linotype" panose="02040502050505030304" pitchFamily="18" charset="0"/>
              </a:rPr>
              <a:t>This result was made from a representative experiment. </a:t>
            </a:r>
            <a:endParaRPr lang="ko-KR" altLang="en-US" sz="1600" dirty="0">
              <a:latin typeface="Palatino Linotype" panose="02040502050505030304" pitchFamily="18" charset="0"/>
              <a:cs typeface="Times New Roman"/>
            </a:endParaRPr>
          </a:p>
        </p:txBody>
      </p:sp>
      <p:grpSp>
        <p:nvGrpSpPr>
          <p:cNvPr id="10" name="Group 14">
            <a:extLst>
              <a:ext uri="{FF2B5EF4-FFF2-40B4-BE49-F238E27FC236}">
                <a16:creationId xmlns:a16="http://schemas.microsoft.com/office/drawing/2014/main" xmlns="" id="{EC4EDEFB-D10C-48D0-BAFC-A733F674E853}"/>
              </a:ext>
            </a:extLst>
          </p:cNvPr>
          <p:cNvGrpSpPr/>
          <p:nvPr/>
        </p:nvGrpSpPr>
        <p:grpSpPr>
          <a:xfrm rot="16200000">
            <a:off x="3130169" y="2954844"/>
            <a:ext cx="1450706" cy="2465685"/>
            <a:chOff x="2580261" y="5996332"/>
            <a:chExt cx="1654257" cy="2811650"/>
          </a:xfrm>
        </p:grpSpPr>
        <p:pic>
          <p:nvPicPr>
            <p:cNvPr id="11" name="Picture 11">
              <a:extLst>
                <a:ext uri="{FF2B5EF4-FFF2-40B4-BE49-F238E27FC236}">
                  <a16:creationId xmlns:a16="http://schemas.microsoft.com/office/drawing/2014/main" xmlns="" id="{85FEE1CB-7398-4126-A698-9BD398995E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8160" b="48628"/>
            <a:stretch/>
          </p:blipFill>
          <p:spPr>
            <a:xfrm rot="5400000">
              <a:off x="2404323" y="6977787"/>
              <a:ext cx="2811650" cy="848740"/>
            </a:xfrm>
            <a:prstGeom prst="rect">
              <a:avLst/>
            </a:prstGeom>
          </p:spPr>
        </p:pic>
        <p:pic>
          <p:nvPicPr>
            <p:cNvPr id="12" name="Picture 13">
              <a:extLst>
                <a:ext uri="{FF2B5EF4-FFF2-40B4-BE49-F238E27FC236}">
                  <a16:creationId xmlns:a16="http://schemas.microsoft.com/office/drawing/2014/main" xmlns="" id="{0AED85A0-B9B2-4C62-8B33-51F3F39872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99" t="1" r="8147" b="49605"/>
            <a:stretch/>
          </p:blipFill>
          <p:spPr>
            <a:xfrm rot="5400000" flipV="1">
              <a:off x="1598806" y="6977787"/>
              <a:ext cx="2811649" cy="848740"/>
            </a:xfrm>
            <a:prstGeom prst="rect">
              <a:avLst/>
            </a:prstGeom>
          </p:spPr>
        </p:pic>
      </p:grpSp>
      <p:sp>
        <p:nvSpPr>
          <p:cNvPr id="13" name="TextBox 12"/>
          <p:cNvSpPr txBox="1"/>
          <p:nvPr/>
        </p:nvSpPr>
        <p:spPr>
          <a:xfrm>
            <a:off x="1972680" y="3695978"/>
            <a:ext cx="931683" cy="3308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ko-KR" sz="1550">
                <a:latin typeface="Times New Roman"/>
                <a:ea typeface="맑은 고딕"/>
                <a:cs typeface="Times New Roman"/>
              </a:rPr>
              <a:t>CLR</a:t>
            </a:r>
            <a:endParaRPr lang="en-US" altLang="ko-KR" sz="1550"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87411" y="4392872"/>
            <a:ext cx="507861" cy="3353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79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endParaRPr lang="ko-KR" altLang="en-US" sz="157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2555178" y="3244529"/>
            <a:ext cx="0" cy="90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2541813" y="4250852"/>
            <a:ext cx="0" cy="90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직각 삼각형 16"/>
          <p:cNvSpPr/>
          <p:nvPr/>
        </p:nvSpPr>
        <p:spPr>
          <a:xfrm>
            <a:off x="2619204" y="3224590"/>
            <a:ext cx="2418042" cy="216000"/>
          </a:xfrm>
          <a:prstGeom prst="rtTriangle">
            <a:avLst/>
          </a:prstGeom>
          <a:solidFill>
            <a:schemeClr val="tx1">
              <a:lumMod val="65000"/>
              <a:lumOff val="3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각 삼각형 17"/>
          <p:cNvSpPr/>
          <p:nvPr/>
        </p:nvSpPr>
        <p:spPr>
          <a:xfrm rot="10800000" flipH="1">
            <a:off x="2622679" y="4946305"/>
            <a:ext cx="2418042" cy="216000"/>
          </a:xfrm>
          <a:prstGeom prst="rt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2660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74861" y="6550960"/>
            <a:ext cx="7222225" cy="2593659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2. Growth curves of </a:t>
            </a:r>
            <a:r>
              <a:rPr lang="en-US" altLang="ko-KR" sz="16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6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bscessus</a:t>
            </a:r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under aerobic and anaerobic conditions.</a:t>
            </a:r>
          </a:p>
          <a:p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ccording to the Wayne model, the growth curves of </a:t>
            </a:r>
            <a:r>
              <a:rPr lang="en-US" altLang="ko-KR" sz="16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. </a:t>
            </a:r>
            <a:r>
              <a:rPr lang="en-US" altLang="ko-KR" sz="1600" i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bscessus</a:t>
            </a:r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cultured under aeration and non-aeration state. </a:t>
            </a:r>
            <a:r>
              <a:rPr lang="en-US" altLang="ko-KR" sz="16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. abscesses</a:t>
            </a:r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were grown in 7H9 broth until the mid-log phase. For fully replicating aerobic cultures, 10 ml medium was inoculated in the flask and incubated at 37 °C on rotation at 180 rpm. Anaerobic cultures were placed into anaerobic jars. Every indicated time, be read at OD</a:t>
            </a:r>
            <a:r>
              <a:rPr lang="en-US" altLang="ko-KR" sz="1600" baseline="-25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600</a:t>
            </a:r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for up to 96 hours</a:t>
            </a:r>
            <a:r>
              <a:rPr lang="en-US" altLang="ko-KR" sz="16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600" dirty="0">
                <a:latin typeface="Palatino Linotype" panose="02040502050505030304" pitchFamily="18" charset="0"/>
              </a:rPr>
              <a:t>This result was made from a representative experiment.</a:t>
            </a:r>
            <a:r>
              <a:rPr lang="en-US" altLang="ko-KR" sz="16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▽: indicate fading and de-colorization of the oxygen indicator methylene blue.</a:t>
            </a:r>
          </a:p>
          <a:p>
            <a:r>
              <a:rPr lang="en-US" altLang="ko-KR" sz="1600" dirty="0" err="1">
                <a:latin typeface="Palatino Linotype" panose="02040502050505030304" pitchFamily="18" charset="0"/>
                <a:ea typeface="Yu Gothic UI" panose="020B0500000000000000" pitchFamily="34" charset="-128"/>
                <a:cs typeface="Times New Roman" panose="02020603050405020304" pitchFamily="18" charset="0"/>
              </a:rPr>
              <a:t>〇</a:t>
            </a:r>
            <a:r>
              <a:rPr lang="en-US" altLang="ko-KR" sz="1600" dirty="0">
                <a:latin typeface="Palatino Linotype" panose="02040502050505030304" pitchFamily="18" charset="0"/>
                <a:ea typeface="Yu Gothic UI" panose="020B0500000000000000" pitchFamily="34" charset="-128"/>
                <a:cs typeface="Times New Roman" panose="02020603050405020304" pitchFamily="18" charset="0"/>
              </a:rPr>
              <a:t> : indicate the change to aerobe culture condition after 80h.</a:t>
            </a:r>
            <a:endParaRPr lang="en-US" altLang="ko-KR" sz="1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234517" y="273278"/>
            <a:ext cx="6396010" cy="5988050"/>
            <a:chOff x="234517" y="273278"/>
            <a:chExt cx="6396010" cy="5988050"/>
          </a:xfrm>
        </p:grpSpPr>
        <p:sp>
          <p:nvSpPr>
            <p:cNvPr id="7" name="TextBox 6"/>
            <p:cNvSpPr txBox="1"/>
            <p:nvPr/>
          </p:nvSpPr>
          <p:spPr>
            <a:xfrm>
              <a:off x="2182966" y="4255369"/>
              <a:ext cx="16715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Non-replicating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126615" y="1734067"/>
              <a:ext cx="16715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>
                  <a:latin typeface="Arial" panose="020B0604020202020204" pitchFamily="34" charset="0"/>
                  <a:cs typeface="Arial" panose="020B0604020202020204" pitchFamily="34" charset="0"/>
                </a:rPr>
                <a:t>Replicating</a:t>
              </a:r>
              <a:endParaRPr lang="ko-KR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그룹 15"/>
            <p:cNvGrpSpPr/>
            <p:nvPr/>
          </p:nvGrpSpPr>
          <p:grpSpPr>
            <a:xfrm>
              <a:off x="2208637" y="4462807"/>
              <a:ext cx="1981204" cy="216000"/>
              <a:chOff x="1119116" y="8366078"/>
              <a:chExt cx="1981204" cy="555920"/>
            </a:xfrm>
          </p:grpSpPr>
          <p:cxnSp>
            <p:nvCxnSpPr>
              <p:cNvPr id="5" name="직선 연결선 4"/>
              <p:cNvCxnSpPr/>
              <p:nvPr/>
            </p:nvCxnSpPr>
            <p:spPr>
              <a:xfrm>
                <a:off x="1119116" y="8366078"/>
                <a:ext cx="0" cy="54000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직선 연결선 9"/>
              <p:cNvCxnSpPr/>
              <p:nvPr/>
            </p:nvCxnSpPr>
            <p:spPr>
              <a:xfrm>
                <a:off x="3100320" y="8381998"/>
                <a:ext cx="0" cy="54000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직선 연결선 14"/>
              <p:cNvCxnSpPr/>
              <p:nvPr/>
            </p:nvCxnSpPr>
            <p:spPr>
              <a:xfrm>
                <a:off x="1119116" y="8652681"/>
                <a:ext cx="1980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그룹 16"/>
            <p:cNvGrpSpPr/>
            <p:nvPr/>
          </p:nvGrpSpPr>
          <p:grpSpPr>
            <a:xfrm>
              <a:off x="4649323" y="2004415"/>
              <a:ext cx="1981204" cy="216000"/>
              <a:chOff x="1119116" y="8366078"/>
              <a:chExt cx="1981204" cy="555920"/>
            </a:xfrm>
          </p:grpSpPr>
          <p:cxnSp>
            <p:nvCxnSpPr>
              <p:cNvPr id="18" name="직선 연결선 17"/>
              <p:cNvCxnSpPr/>
              <p:nvPr/>
            </p:nvCxnSpPr>
            <p:spPr>
              <a:xfrm>
                <a:off x="1119116" y="8366078"/>
                <a:ext cx="0" cy="54000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직선 연결선 18"/>
              <p:cNvCxnSpPr/>
              <p:nvPr/>
            </p:nvCxnSpPr>
            <p:spPr>
              <a:xfrm>
                <a:off x="3100320" y="8381998"/>
                <a:ext cx="0" cy="54000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직선 연결선 19"/>
              <p:cNvCxnSpPr/>
              <p:nvPr/>
            </p:nvCxnSpPr>
            <p:spPr>
              <a:xfrm>
                <a:off x="1119116" y="8652681"/>
                <a:ext cx="198000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21" name="개체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20557463"/>
                </p:ext>
              </p:extLst>
            </p:nvPr>
          </p:nvGraphicFramePr>
          <p:xfrm>
            <a:off x="234517" y="273278"/>
            <a:ext cx="6261100" cy="5988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34" name="Prism 5" r:id="rId3" imgW="4104000" imgH="3924000" progId="Prism5.Document">
                    <p:embed/>
                  </p:oleObj>
                </mc:Choice>
                <mc:Fallback>
                  <p:oleObj name="Prism 5" r:id="rId3" imgW="4104000" imgH="3924000" progId="Prism5.Document">
                    <p:embed/>
                    <p:pic>
                      <p:nvPicPr>
                        <p:cNvPr id="21" name="개체 20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34517" y="273278"/>
                          <a:ext cx="6261100" cy="5988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4798700" y="2854429"/>
              <a:ext cx="17164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b="1" err="1">
                  <a:latin typeface="Arial Black" panose="020B0A04020102020204" pitchFamily="34" charset="0"/>
                </a:rPr>
                <a:t>〇</a:t>
              </a:r>
              <a:r>
                <a:rPr lang="ko-KR" altLang="en-US" b="1">
                  <a:latin typeface="Arial Black" panose="020B0A04020102020204" pitchFamily="34" charset="0"/>
                </a:rPr>
                <a:t>   </a:t>
              </a:r>
              <a:r>
                <a:rPr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Re-aerobic</a:t>
              </a:r>
              <a:endParaRPr lang="ko-KR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264113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/>
        </p:nvGraphicFramePr>
        <p:xfrm>
          <a:off x="1684338" y="3463925"/>
          <a:ext cx="3867150" cy="270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5" name="Prism 5" r:id="rId3" imgW="4572000" imgH="3204000" progId="Prism5.Document">
                  <p:embed/>
                </p:oleObj>
              </mc:Choice>
              <mc:Fallback>
                <p:oleObj name="Prism 5" r:id="rId3" imgW="4572000" imgH="3204000" progId="Prism5.Document">
                  <p:embed/>
                  <p:pic>
                    <p:nvPicPr>
                      <p:cNvPr id="5" name="개체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84338" y="3463925"/>
                        <a:ext cx="3867150" cy="27082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579756" y="3461897"/>
            <a:ext cx="400943" cy="3353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79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579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512932" y="900105"/>
            <a:ext cx="400943" cy="3353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79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579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286603" y="6211808"/>
            <a:ext cx="7124131" cy="2339102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S3. 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Effects of CC on cell viability and 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cytotoxicity.</a:t>
            </a:r>
            <a:endParaRPr lang="ko-KR" altLang="en-US" sz="1600" dirty="0">
              <a:latin typeface="Palatino Linotype" panose="02040502050505030304" pitchFamily="18" charset="0"/>
              <a:cs typeface="Times New Roman"/>
            </a:endParaRPr>
          </a:p>
          <a:p>
            <a:pPr algn="just"/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Effect of CC on viability (A) and cytotoxicity (B) in human Colon epithelial Cells (HCT-8) and human monocyte-macrophage cells (THP-1).  Cells were treated for 24 hours with increasing concentrations of CC, viability was determined using the WST-8 assay (</a:t>
            </a:r>
            <a:r>
              <a:rPr lang="en-US" sz="1600" dirty="0" err="1">
                <a:latin typeface="Palatino Linotype" panose="02040502050505030304" pitchFamily="18" charset="0"/>
                <a:ea typeface="+mn-lt"/>
                <a:cs typeface="Times New Roman"/>
              </a:rPr>
              <a:t>CellRix</a:t>
            </a:r>
            <a:r>
              <a:rPr lang="en-US" altLang="ko-KR" sz="1600" dirty="0">
                <a:latin typeface="Palatino Linotype" panose="02040502050505030304" pitchFamily="18" charset="0"/>
                <a:ea typeface="+mn-lt"/>
                <a:cs typeface="Times New Roman"/>
              </a:rPr>
              <a:t>Ⓡ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) and </a:t>
            </a:r>
            <a:r>
              <a:rPr lang="en-US" sz="1600" dirty="0" err="1">
                <a:latin typeface="Palatino Linotype" panose="02040502050505030304" pitchFamily="18" charset="0"/>
                <a:ea typeface="+mn-lt"/>
                <a:cs typeface="Times New Roman"/>
              </a:rPr>
              <a:t>CytoTox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 96® Non-Radioactive Cytotoxicity Assay (Promega) kit.  The percentage of cell survival was determined based on control cells incubated in a DMSO-containing medium. Data were expressed as the mean ± SD of triplicates for each tested </a:t>
            </a:r>
            <a:r>
              <a:rPr lang="en-US" sz="1600" dirty="0" smtClean="0">
                <a:latin typeface="Palatino Linotype" panose="02040502050505030304" pitchFamily="18" charset="0"/>
                <a:ea typeface="+mn-lt"/>
                <a:cs typeface="Times New Roman"/>
              </a:rPr>
              <a:t>concentration.</a:t>
            </a:r>
            <a:r>
              <a:rPr lang="en-US" sz="1600" dirty="0">
                <a:latin typeface="Palatino Linotype" panose="02040502050505030304" pitchFamily="18" charset="0"/>
                <a:ea typeface="+mn-lt"/>
                <a:cs typeface="Times New Roman"/>
              </a:rPr>
              <a:t> </a:t>
            </a:r>
            <a:r>
              <a:rPr lang="en-US" altLang="ko-KR" sz="1600" dirty="0">
                <a:latin typeface="Palatino Linotype" panose="02040502050505030304" pitchFamily="18" charset="0"/>
              </a:rPr>
              <a:t> This result was made from a representative experiment. </a:t>
            </a:r>
            <a:endParaRPr lang="ko-KR" sz="1600" dirty="0">
              <a:latin typeface="Palatino Linotype" panose="02040502050505030304" pitchFamily="18" charset="0"/>
              <a:cs typeface="Times New Roman"/>
            </a:endParaRPr>
          </a:p>
        </p:txBody>
      </p:sp>
      <p:graphicFrame>
        <p:nvGraphicFramePr>
          <p:cNvPr id="3" name="개체 2"/>
          <p:cNvGraphicFramePr>
            <a:graphicFrameLocks noChangeAspect="1"/>
          </p:cNvGraphicFramePr>
          <p:nvPr/>
        </p:nvGraphicFramePr>
        <p:xfrm>
          <a:off x="1687513" y="538163"/>
          <a:ext cx="4211637" cy="316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6" name="Prism 5" r:id="rId5" imgW="4212000" imgH="3168000" progId="Prism5.Document">
                  <p:embed/>
                </p:oleObj>
              </mc:Choice>
              <mc:Fallback>
                <p:oleObj name="Prism 5" r:id="rId5" imgW="4212000" imgH="3168000" progId="Prism5.Document">
                  <p:embed/>
                  <p:pic>
                    <p:nvPicPr>
                      <p:cNvPr id="3" name="개체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87513" y="538163"/>
                        <a:ext cx="4211637" cy="316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8814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</TotalTime>
  <Words>178</Words>
  <Application>Microsoft Office PowerPoint</Application>
  <PresentationFormat>사용자 지정</PresentationFormat>
  <Paragraphs>13</Paragraphs>
  <Slides>3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5" baseType="lpstr">
      <vt:lpstr>Office 테마</vt:lpstr>
      <vt:lpstr>Prism 5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SAMSUNG</cp:lastModifiedBy>
  <cp:revision>16</cp:revision>
  <cp:lastPrinted>2021-06-19T11:23:10Z</cp:lastPrinted>
  <dcterms:created xsi:type="dcterms:W3CDTF">2021-04-20T13:55:28Z</dcterms:created>
  <dcterms:modified xsi:type="dcterms:W3CDTF">2021-10-05T06:43:59Z</dcterms:modified>
</cp:coreProperties>
</file>